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1548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1670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1174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928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2617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6682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5874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821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5255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2337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1247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889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9749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1547664" y="404664"/>
            <a:ext cx="5472608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sz="1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T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PCR amplification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 for toxigenic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steurella</a:t>
            </a:r>
            <a:r>
              <a:rPr lang="en-US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ltocida</a:t>
            </a:r>
            <a:endParaRPr lang="en-GB" sz="11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hteck 6"/>
          <p:cNvSpPr/>
          <p:nvPr/>
        </p:nvSpPr>
        <p:spPr>
          <a:xfrm>
            <a:off x="755576" y="5212720"/>
            <a:ext cx="795072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lification plot of the </a:t>
            </a:r>
            <a:r>
              <a:rPr lang="en-GB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PCR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ay of </a:t>
            </a:r>
            <a:r>
              <a:rPr lang="en-GB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xA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ing a dilution series ranging from 20,000,000, 2,000,000, 200,000, 20,000, 2,000 to 200 genome equivalents (red curves, left to right). The green curves show the amplification of the internal amplification control (IAC) </a:t>
            </a:r>
            <a:r>
              <a:rPr lang="en-GB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GFP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6" name="Grafik 5" descr="C:\Users\ss\Desktop\Amplification Plot_wasserlyse_vetPath.jpg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7" t="2846" r="-20" b="14795"/>
          <a:stretch/>
        </p:blipFill>
        <p:spPr bwMode="auto">
          <a:xfrm>
            <a:off x="251520" y="836712"/>
            <a:ext cx="8238758" cy="41420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312463531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Bildschirmpräsentatio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imone Scherrer</dc:creator>
  <cp:lastModifiedBy>Simone Scherrer</cp:lastModifiedBy>
  <cp:revision>17</cp:revision>
  <dcterms:created xsi:type="dcterms:W3CDTF">2016-06-29T11:21:39Z</dcterms:created>
  <dcterms:modified xsi:type="dcterms:W3CDTF">2016-10-27T12:07:23Z</dcterms:modified>
</cp:coreProperties>
</file>